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customXml/itemProps4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5"/>
  </p:sldMasterIdLst>
  <p:notesMasterIdLst>
    <p:notesMasterId r:id="rId11"/>
  </p:notesMasterIdLst>
  <p:sldIdLst>
    <p:sldId id="282" r:id="rId6"/>
    <p:sldId id="284" r:id="rId7"/>
    <p:sldId id="285" r:id="rId8"/>
    <p:sldId id="268" r:id="rId9"/>
    <p:sldId id="283" r:id="rId10"/>
  </p:sldIdLst>
  <p:sldSz cx="6858000" cy="9906000" type="A4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097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CF6ECD03-D8A0-885A-53F9-C961BA8D3D64}" name="Julie Dalziel" initials="JD" userId="S::julie.dalziel@agresearch.co.nz::495a2e35-0973-4dbe-b6d7-43d4d15ef592" providerId="AD"/>
  <p188:author id="{D0533B78-35B1-520E-617C-460B5205AAE8}" name="Raise Ahmad" initials="RA" userId="S::Raise.Ahmad@agresearch.co.nz::b332e40c-04c9-4569-a447-b58e9d370418" providerId="AD"/>
  <p188:author id="{030B40EA-D6AA-B2A4-BC97-4F61433CD2AF}" name="Gosia Zobel" initials="GZ" userId="S::gosia.zobel@agresearch.co.nz::8cef703c-0a4e-4ba8-926d-70db6e2e6d6f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B8AAD"/>
    <a:srgbClr val="537397"/>
    <a:srgbClr val="7ECCA7"/>
    <a:srgbClr val="557B95"/>
    <a:srgbClr val="89E3E3"/>
    <a:srgbClr val="7B9CB3"/>
    <a:srgbClr val="FDE725"/>
    <a:srgbClr val="72C4B6"/>
    <a:srgbClr val="F6E974"/>
    <a:srgbClr val="EBEBE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BF19CAE5-8E21-4E71-8C1F-582C4634E362}" v="4" dt="2026-03-10T01:46:15.996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70" d="100"/>
          <a:sy n="70" d="100"/>
        </p:scale>
        <p:origin x="3204" y="90"/>
      </p:cViewPr>
      <p:guideLst>
        <p:guide orient="horz" pos="3097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3.xml"/><Relationship Id="rId13" Type="http://schemas.openxmlformats.org/officeDocument/2006/relationships/viewProps" Target="viewProps.xml"/><Relationship Id="rId18" Type="http://schemas.microsoft.com/office/2018/10/relationships/authors" Target="authors.xml"/><Relationship Id="rId3" Type="http://schemas.openxmlformats.org/officeDocument/2006/relationships/customXml" Target="../customXml/item3.xml"/><Relationship Id="rId7" Type="http://schemas.openxmlformats.org/officeDocument/2006/relationships/slide" Target="slides/slide2.xml"/><Relationship Id="rId12" Type="http://schemas.openxmlformats.org/officeDocument/2006/relationships/presProps" Target="presProps.xml"/><Relationship Id="rId17" Type="http://schemas.microsoft.com/office/2015/10/relationships/revisionInfo" Target="revisionInfo.xml"/><Relationship Id="rId2" Type="http://schemas.openxmlformats.org/officeDocument/2006/relationships/customXml" Target="../customXml/item2.xml"/><Relationship Id="rId16" Type="http://schemas.microsoft.com/office/2016/11/relationships/changesInfo" Target="changesInfos/changesInfo1.xml"/><Relationship Id="rId1" Type="http://schemas.openxmlformats.org/officeDocument/2006/relationships/customXml" Target="../customXml/item1.xml"/><Relationship Id="rId6" Type="http://schemas.openxmlformats.org/officeDocument/2006/relationships/slide" Target="slides/slide1.xml"/><Relationship Id="rId11" Type="http://schemas.openxmlformats.org/officeDocument/2006/relationships/notesMaster" Target="notesMasters/notesMaster1.xml"/><Relationship Id="rId5" Type="http://schemas.openxmlformats.org/officeDocument/2006/relationships/slideMaster" Target="slideMasters/slideMaster1.xml"/><Relationship Id="rId15" Type="http://schemas.openxmlformats.org/officeDocument/2006/relationships/tableStyles" Target="tableStyles.xml"/><Relationship Id="rId10" Type="http://schemas.openxmlformats.org/officeDocument/2006/relationships/slide" Target="slides/slide5.xml"/><Relationship Id="rId4" Type="http://schemas.openxmlformats.org/officeDocument/2006/relationships/customXml" Target="../customXml/item4.xml"/><Relationship Id="rId9" Type="http://schemas.openxmlformats.org/officeDocument/2006/relationships/slide" Target="slides/slide4.xml"/><Relationship Id="rId14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ulie Dalziel" userId="495a2e35-0973-4dbe-b6d7-43d4d15ef592" providerId="ADAL" clId="{DAD9F743-34DF-45C5-8089-0892E05068DD}"/>
    <pc:docChg chg="addSld delSld modSld">
      <pc:chgData name="Julie Dalziel" userId="495a2e35-0973-4dbe-b6d7-43d4d15ef592" providerId="ADAL" clId="{DAD9F743-34DF-45C5-8089-0892E05068DD}" dt="2026-03-10T01:46:23.030" v="7" actId="47"/>
      <pc:docMkLst>
        <pc:docMk/>
      </pc:docMkLst>
      <pc:sldChg chg="add del">
        <pc:chgData name="Julie Dalziel" userId="495a2e35-0973-4dbe-b6d7-43d4d15ef592" providerId="ADAL" clId="{DAD9F743-34DF-45C5-8089-0892E05068DD}" dt="2026-03-10T01:46:19.476" v="6" actId="47"/>
        <pc:sldMkLst>
          <pc:docMk/>
          <pc:sldMk cId="567682433" sldId="263"/>
        </pc:sldMkLst>
      </pc:sldChg>
      <pc:sldChg chg="del">
        <pc:chgData name="Julie Dalziel" userId="495a2e35-0973-4dbe-b6d7-43d4d15ef592" providerId="ADAL" clId="{DAD9F743-34DF-45C5-8089-0892E05068DD}" dt="2026-03-10T01:46:23.030" v="7" actId="47"/>
        <pc:sldMkLst>
          <pc:docMk/>
          <pc:sldMk cId="3108785058" sldId="265"/>
        </pc:sldMkLst>
      </pc:sldChg>
      <pc:sldChg chg="add">
        <pc:chgData name="Julie Dalziel" userId="495a2e35-0973-4dbe-b6d7-43d4d15ef592" providerId="ADAL" clId="{DAD9F743-34DF-45C5-8089-0892E05068DD}" dt="2026-03-10T01:45:32.348" v="0"/>
        <pc:sldMkLst>
          <pc:docMk/>
          <pc:sldMk cId="104996960" sldId="284"/>
        </pc:sldMkLst>
      </pc:sldChg>
      <pc:sldChg chg="add">
        <pc:chgData name="Julie Dalziel" userId="495a2e35-0973-4dbe-b6d7-43d4d15ef592" providerId="ADAL" clId="{DAD9F743-34DF-45C5-8089-0892E05068DD}" dt="2026-03-10T01:46:15.996" v="5"/>
        <pc:sldMkLst>
          <pc:docMk/>
          <pc:sldMk cId="119149797" sldId="285"/>
        </pc:sldMkLst>
      </pc:sldChg>
    </pc:docChg>
  </pc:docChgLst>
  <pc:docChgLst>
    <pc:chgData name="Julie Dalziel" userId="S::julie.dalziel@agresearch.co.nz::495a2e35-0973-4dbe-b6d7-43d4d15ef592" providerId="AD" clId="Web-{0225C54D-7BCC-4B98-9E42-1947CB2A1D49}"/>
    <pc:docChg chg="delSld">
      <pc:chgData name="Julie Dalziel" userId="S::julie.dalziel@agresearch.co.nz::495a2e35-0973-4dbe-b6d7-43d4d15ef592" providerId="AD" clId="Web-{0225C54D-7BCC-4B98-9E42-1947CB2A1D49}" dt="2026-02-23T23:02:55.807" v="6"/>
      <pc:docMkLst>
        <pc:docMk/>
      </pc:docMkLst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NZ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876484F-3046-4FCF-9964-6A6F22316207}" type="datetimeFigureOut">
              <a:rPr lang="en-NZ" smtClean="0"/>
              <a:t>10/03/2026</a:t>
            </a:fld>
            <a:endParaRPr lang="en-NZ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NZ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A7DF999-2AA6-406D-94E7-8226D6BEDA7D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3263980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NZ"/>
              <a:t>Brain region had the greatest effect – need to do stats by region and comment on this to compare with the literatur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A7DF999-2AA6-406D-94E7-8226D6BEDA7D}" type="slidenum">
              <a:rPr lang="en-NZ" smtClean="0"/>
              <a:t>2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23689414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A7DF999-2AA6-406D-94E7-8226D6BEDA7D}" type="slidenum">
              <a:rPr lang="en-NZ" smtClean="0"/>
              <a:t>4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56756125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52BBA9-F1FC-4D58-8320-E0874BF2AAE5}" type="datetimeFigureOut">
              <a:rPr lang="en-NZ" smtClean="0"/>
              <a:t>10/03/2026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882383-A6DA-4943-ACE2-539E4A59821A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3127334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52BBA9-F1FC-4D58-8320-E0874BF2AAE5}" type="datetimeFigureOut">
              <a:rPr lang="en-NZ" smtClean="0"/>
              <a:t>10/03/2026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882383-A6DA-4943-ACE2-539E4A59821A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5191377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52BBA9-F1FC-4D58-8320-E0874BF2AAE5}" type="datetimeFigureOut">
              <a:rPr lang="en-NZ" smtClean="0"/>
              <a:t>10/03/2026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882383-A6DA-4943-ACE2-539E4A59821A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40654429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52BBA9-F1FC-4D58-8320-E0874BF2AAE5}" type="datetimeFigureOut">
              <a:rPr lang="en-NZ" smtClean="0"/>
              <a:t>10/03/2026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882383-A6DA-4943-ACE2-539E4A59821A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0336855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52BBA9-F1FC-4D58-8320-E0874BF2AAE5}" type="datetimeFigureOut">
              <a:rPr lang="en-NZ" smtClean="0"/>
              <a:t>10/03/2026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882383-A6DA-4943-ACE2-539E4A59821A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697426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52BBA9-F1FC-4D58-8320-E0874BF2AAE5}" type="datetimeFigureOut">
              <a:rPr lang="en-NZ" smtClean="0"/>
              <a:t>10/03/2026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882383-A6DA-4943-ACE2-539E4A59821A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641624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52BBA9-F1FC-4D58-8320-E0874BF2AAE5}" type="datetimeFigureOut">
              <a:rPr lang="en-NZ" smtClean="0"/>
              <a:t>10/03/2026</a:t>
            </a:fld>
            <a:endParaRPr lang="en-NZ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882383-A6DA-4943-ACE2-539E4A59821A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7093950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52BBA9-F1FC-4D58-8320-E0874BF2AAE5}" type="datetimeFigureOut">
              <a:rPr lang="en-NZ" smtClean="0"/>
              <a:t>10/03/2026</a:t>
            </a:fld>
            <a:endParaRPr lang="en-NZ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882383-A6DA-4943-ACE2-539E4A59821A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42128853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52BBA9-F1FC-4D58-8320-E0874BF2AAE5}" type="datetimeFigureOut">
              <a:rPr lang="en-NZ" smtClean="0"/>
              <a:t>10/03/2026</a:t>
            </a:fld>
            <a:endParaRPr lang="en-NZ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882383-A6DA-4943-ACE2-539E4A59821A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6206867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52BBA9-F1FC-4D58-8320-E0874BF2AAE5}" type="datetimeFigureOut">
              <a:rPr lang="en-NZ" smtClean="0"/>
              <a:t>10/03/2026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882383-A6DA-4943-ACE2-539E4A59821A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520980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52BBA9-F1FC-4D58-8320-E0874BF2AAE5}" type="datetimeFigureOut">
              <a:rPr lang="en-NZ" smtClean="0"/>
              <a:t>10/03/2026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882383-A6DA-4943-ACE2-539E4A59821A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3422681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52BBA9-F1FC-4D58-8320-E0874BF2AAE5}" type="datetimeFigureOut">
              <a:rPr lang="en-NZ" smtClean="0"/>
              <a:t>10/03/2026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882383-A6DA-4943-ACE2-539E4A59821A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8460417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.sv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FC5D2D0-725A-E819-ED0D-19CAE00E97A6}"/>
              </a:ext>
            </a:extLst>
          </p:cNvPr>
          <p:cNvSpPr txBox="1"/>
          <p:nvPr/>
        </p:nvSpPr>
        <p:spPr>
          <a:xfrm>
            <a:off x="463499" y="569566"/>
            <a:ext cx="13147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/>
              <a:t>Suppl. Fig. 1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7D180D6-437A-B0D1-5018-F8FBA3484BE7}"/>
              </a:ext>
            </a:extLst>
          </p:cNvPr>
          <p:cNvSpPr txBox="1"/>
          <p:nvPr/>
        </p:nvSpPr>
        <p:spPr>
          <a:xfrm>
            <a:off x="1021976" y="7234518"/>
            <a:ext cx="5553635" cy="553998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NZ" sz="1200" b="1"/>
              <a:t>Supplemental Figure 1.</a:t>
            </a:r>
            <a:r>
              <a:rPr lang="en-NZ" sz="1200"/>
              <a:t> Changes in body weight over the duration of the study.</a:t>
            </a:r>
          </a:p>
          <a:p>
            <a:endParaRPr lang="en-NZ"/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463E857D-B164-0D61-ED50-8D9F73C4006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55734" y="3059057"/>
            <a:ext cx="3436990" cy="37878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729498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D574EB3F-A22A-1DFB-F2B0-C76BE86023E5}"/>
              </a:ext>
            </a:extLst>
          </p:cNvPr>
          <p:cNvSpPr txBox="1"/>
          <p:nvPr/>
        </p:nvSpPr>
        <p:spPr>
          <a:xfrm>
            <a:off x="720675" y="8389591"/>
            <a:ext cx="579442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1200" b="1" dirty="0"/>
              <a:t>Supplemental Figure 2. </a:t>
            </a:r>
            <a:r>
              <a:rPr lang="en-NZ" sz="1200" dirty="0"/>
              <a:t>Heatmap of showing differences in brain gene expression in amygdala (AMG), hippocampus (HPC), and prefrontal cortex (PFC) among treatment groups for paired females, FP (n=16), single females, FS (n=8), paired males, MP (n=16), and single males, MS (n=8).  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8DCED6FE-5D9B-2A57-59BA-BF9A698CCCB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8585" y="873852"/>
            <a:ext cx="6185916" cy="742435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499696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screen shot of a screen&#10;&#10;AI-generated content may be incorrect.">
            <a:extLst>
              <a:ext uri="{FF2B5EF4-FFF2-40B4-BE49-F238E27FC236}">
                <a16:creationId xmlns:a16="http://schemas.microsoft.com/office/drawing/2014/main" id="{D79970B3-201D-38BD-E064-139A7D16F8F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5281" y="1003255"/>
            <a:ext cx="5848502" cy="7019392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D7A3D251-9BF8-948A-675F-6D653C39D57C}"/>
              </a:ext>
            </a:extLst>
          </p:cNvPr>
          <p:cNvSpPr txBox="1"/>
          <p:nvPr/>
        </p:nvSpPr>
        <p:spPr>
          <a:xfrm>
            <a:off x="720675" y="8341966"/>
            <a:ext cx="579442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1200" b="1" dirty="0"/>
              <a:t>Supplemental Figure 3. </a:t>
            </a:r>
            <a:r>
              <a:rPr lang="en-NZ" sz="1200" dirty="0"/>
              <a:t>Heatmap of showing differences in proximal colon gene expression among treatment groups for paired females, FP (n=16), single females, FS (n=8), paired males, MP (n=16), and single males, MS (n=8).  </a:t>
            </a:r>
          </a:p>
        </p:txBody>
      </p:sp>
    </p:spTree>
    <p:extLst>
      <p:ext uri="{BB962C8B-B14F-4D97-AF65-F5344CB8AC3E}">
        <p14:creationId xmlns:p14="http://schemas.microsoft.com/office/powerpoint/2010/main" val="11914979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5EE320CE-29E5-6AA3-D91A-4E8249119EC8}"/>
              </a:ext>
            </a:extLst>
          </p:cNvPr>
          <p:cNvSpPr txBox="1"/>
          <p:nvPr/>
        </p:nvSpPr>
        <p:spPr>
          <a:xfrm>
            <a:off x="463499" y="569566"/>
            <a:ext cx="544610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/>
              <a:t>Suppl. Fig. 4 Microbiota - </a:t>
            </a:r>
            <a:r>
              <a:rPr lang="en-US"/>
              <a:t>Top 30 Most Abundant Genera</a:t>
            </a:r>
            <a:endParaRPr lang="en-NZ"/>
          </a:p>
          <a:p>
            <a:endParaRPr lang="en-NZ"/>
          </a:p>
        </p:txBody>
      </p:sp>
      <p:pic>
        <p:nvPicPr>
          <p:cNvPr id="3" name="Graphic 2">
            <a:extLst>
              <a:ext uri="{FF2B5EF4-FFF2-40B4-BE49-F238E27FC236}">
                <a16:creationId xmlns:a16="http://schemas.microsoft.com/office/drawing/2014/main" id="{BD972DCF-3844-C8F2-8B96-9BC6251F374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463499" y="1541822"/>
            <a:ext cx="5905500" cy="52720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8077017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599DFAC0-B61E-00FC-A371-747408B05DD3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696" b="3615"/>
          <a:stretch>
            <a:fillRect/>
          </a:stretch>
        </p:blipFill>
        <p:spPr bwMode="auto">
          <a:xfrm>
            <a:off x="878522" y="1452216"/>
            <a:ext cx="5100955" cy="4636770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B4ECA176-BDAF-B121-A56F-A32BEA35904A}"/>
              </a:ext>
            </a:extLst>
          </p:cNvPr>
          <p:cNvSpPr txBox="1"/>
          <p:nvPr/>
        </p:nvSpPr>
        <p:spPr>
          <a:xfrm>
            <a:off x="878522" y="7206018"/>
            <a:ext cx="5262971" cy="18466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1200"/>
              <a:t>Correlation between key behaviour test parameters identified by the multi-block </a:t>
            </a:r>
            <a:r>
              <a:rPr lang="en-NZ" sz="1200" err="1"/>
              <a:t>sPLS</a:t>
            </a:r>
            <a:r>
              <a:rPr lang="en-NZ" sz="1200"/>
              <a:t>-DA ‘DIABLO’ algorithm implemented in the </a:t>
            </a:r>
            <a:r>
              <a:rPr lang="en-NZ" sz="1200" err="1"/>
              <a:t>mixOmics</a:t>
            </a:r>
            <a:r>
              <a:rPr lang="en-NZ" sz="1200"/>
              <a:t> R package displayed as a </a:t>
            </a:r>
            <a:r>
              <a:rPr lang="en-NZ" sz="1200" err="1"/>
              <a:t>circoplot</a:t>
            </a:r>
            <a:r>
              <a:rPr lang="en-NZ" sz="1200"/>
              <a:t> where variables are displayed in the circle grouped by the type of variables for: brain genes (green); gut genes from proximal colon (purple); gut genera are the different caecal microbiome taxa (red); behaviour parameters (blue) for elevated plus maze (EPM) and open field test (OFT). Variables with a correlation score &gt; 0.65 are joined by a red line and variables with a correlation score &lt; −0.65 are joined by a blue line.</a:t>
            </a:r>
          </a:p>
          <a:p>
            <a:endParaRPr lang="en-NZ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7F0B223-87AC-C69B-6ED2-ADB79BA0C43E}"/>
              </a:ext>
            </a:extLst>
          </p:cNvPr>
          <p:cNvSpPr txBox="1"/>
          <p:nvPr/>
        </p:nvSpPr>
        <p:spPr>
          <a:xfrm>
            <a:off x="463499" y="569566"/>
            <a:ext cx="221195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/>
              <a:t>Suppl. Fig. 5 </a:t>
            </a:r>
            <a:r>
              <a:rPr lang="en-NZ" err="1"/>
              <a:t>Circoplot</a:t>
            </a:r>
            <a:endParaRPr lang="en-NZ"/>
          </a:p>
          <a:p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1097696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_rels/item4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4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C13AD53298B754B937F0D42A18DF9C3" ma:contentTypeVersion="21" ma:contentTypeDescription="Create a new document." ma:contentTypeScope="" ma:versionID="0e35d6d18f97c42750f93241be6f1964">
  <xsd:schema xmlns:xsd="http://www.w3.org/2001/XMLSchema" xmlns:xs="http://www.w3.org/2001/XMLSchema" xmlns:p="http://schemas.microsoft.com/office/2006/metadata/properties" xmlns:ns2="7eac3473-afb6-4782-ba55-074fa82562bd" xmlns:ns3="8274269c-7923-44e4-a9bb-32208af8880d" xmlns:ns4="bfb4a7de-d4b7-4cb9-9528-07cb57dc8ff3" targetNamespace="http://schemas.microsoft.com/office/2006/metadata/properties" ma:root="true" ma:fieldsID="20cd5b4564c9cfad98e7463cc0f5de1a" ns2:_="" ns3:_="" ns4:_="">
    <xsd:import namespace="7eac3473-afb6-4782-ba55-074fa82562bd"/>
    <xsd:import namespace="8274269c-7923-44e4-a9bb-32208af8880d"/>
    <xsd:import namespace="bfb4a7de-d4b7-4cb9-9528-07cb57dc8ff3"/>
    <xsd:element name="properties">
      <xsd:complexType>
        <xsd:sequence>
          <xsd:element name="documentManagement">
            <xsd:complexType>
              <xsd:all>
                <xsd:element ref="ns2:TaxCatchAll" minOccurs="0"/>
                <xsd:element ref="ns2:TaxCatchAllLabel" minOccurs="0"/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DateTaken" minOccurs="0"/>
                <xsd:element ref="ns3:Date_x0020_created" minOccurs="0"/>
                <xsd:element ref="ns4:SharedWithUsers" minOccurs="0"/>
                <xsd:element ref="ns4:SharedWithDetails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OCR" minOccurs="0"/>
                <xsd:element ref="ns3:MediaLengthInSeconds" minOccurs="0"/>
                <xsd:element ref="ns3:MediaServiceLocation" minOccurs="0"/>
                <xsd:element ref="ns3:lcf76f155ced4ddcb4097134ff3c332f" minOccurs="0"/>
                <xsd:element ref="ns3:MediaServiceObjectDetectorVersions" minOccurs="0"/>
                <xsd:element ref="ns3:MediaServiceSearchProperties" minOccurs="0"/>
                <xsd:element ref="ns3:MediaServiceBillingMetadata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eac3473-afb6-4782-ba55-074fa82562bd" elementFormDefault="qualified">
    <xsd:import namespace="http://schemas.microsoft.com/office/2006/documentManagement/types"/>
    <xsd:import namespace="http://schemas.microsoft.com/office/infopath/2007/PartnerControls"/>
    <xsd:element name="TaxCatchAll" ma:index="4" nillable="true" ma:displayName="Taxonomy Catch All Column" ma:hidden="true" ma:list="{64072c89-9f85-4335-93be-2cf3d977c880}" ma:internalName="TaxCatchAll" ma:showField="CatchAllData" ma:web="bfb4a7de-d4b7-4cb9-9528-07cb57dc8ff3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  <xsd:element name="TaxCatchAllLabel" ma:index="5" nillable="true" ma:displayName="Taxonomy Catch All Column1" ma:hidden="true" ma:list="{64072c89-9f85-4335-93be-2cf3d977c880}" ma:internalName="TaxCatchAllLabel" ma:readOnly="true" ma:showField="CatchAllDataLabel" ma:web="bfb4a7de-d4b7-4cb9-9528-07cb57dc8ff3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274269c-7923-44e4-a9bb-32208af8880d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0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1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2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3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4" nillable="true" ma:displayName="MediaServiceDateTaken" ma:hidden="true" ma:internalName="MediaServiceDateTaken" ma:readOnly="true">
      <xsd:simpleType>
        <xsd:restriction base="dms:Text"/>
      </xsd:simpleType>
    </xsd:element>
    <xsd:element name="Date_x0020_created" ma:index="15" nillable="true" ma:displayName="Date created" ma:format="DateOnly" ma:internalName="Date_x0020_created">
      <xsd:simpleType>
        <xsd:restriction base="dms:DateTime"/>
      </xsd:simpleType>
    </xsd:element>
    <xsd:element name="MediaServiceAutoTags" ma:index="18" nillable="true" ma:displayName="Tags" ma:internalName="MediaServiceAutoTags" ma:readOnly="true">
      <xsd:simpleType>
        <xsd:restriction base="dms:Text"/>
      </xsd:simpleType>
    </xsd:element>
    <xsd:element name="MediaServiceGenerationTime" ma:index="19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20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2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LengthInSeconds" ma:index="22" nillable="true" ma:displayName="MediaLengthInSeconds" ma:hidden="true" ma:internalName="MediaLengthInSeconds" ma:readOnly="true">
      <xsd:simpleType>
        <xsd:restriction base="dms:Unknown"/>
      </xsd:simpleType>
    </xsd:element>
    <xsd:element name="MediaServiceLocation" ma:index="23" nillable="true" ma:displayName="Location" ma:internalName="MediaServiceLocation" ma:readOnly="true">
      <xsd:simpleType>
        <xsd:restriction base="dms:Text"/>
      </xsd:simpleType>
    </xsd:element>
    <xsd:element name="lcf76f155ced4ddcb4097134ff3c332f" ma:index="25" nillable="true" ma:taxonomy="true" ma:internalName="lcf76f155ced4ddcb4097134ff3c332f" ma:taxonomyFieldName="MediaServiceImageTags" ma:displayName="Image Tags" ma:readOnly="false" ma:fieldId="{5cf76f15-5ced-4ddc-b409-7134ff3c332f}" ma:taxonomyMulti="true" ma:sspId="12bbd033-7c10-4bc6-94c7-41b14f0b8859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bjectDetectorVersions" ma:index="26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7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BillingMetadata" ma:index="28" nillable="true" ma:displayName="MediaServiceBillingMetadata" ma:hidden="true" ma:internalName="MediaServiceBillingMetadata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bfb4a7de-d4b7-4cb9-9528-07cb57dc8ff3" elementFormDefault="qualified">
    <xsd:import namespace="http://schemas.microsoft.com/office/2006/documentManagement/types"/>
    <xsd:import namespace="http://schemas.microsoft.com/office/infopath/2007/PartnerControls"/>
    <xsd:element name="SharedWithUsers" ma:index="16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7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7" ma:displayName="Content Type"/>
        <xsd:element ref="dc:title" minOccurs="0" maxOccurs="1" ma:index="1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Date_x0020_created xmlns="8274269c-7923-44e4-a9bb-32208af8880d" xsi:nil="true"/>
    <TaxCatchAll xmlns="7eac3473-afb6-4782-ba55-074fa82562bd" xsi:nil="true"/>
    <lcf76f155ced4ddcb4097134ff3c332f xmlns="8274269c-7923-44e4-a9bb-32208af8880d">
      <Terms xmlns="http://schemas.microsoft.com/office/infopath/2007/PartnerControls"/>
    </lcf76f155ced4ddcb4097134ff3c332f>
    <SharedWithUsers xmlns="bfb4a7de-d4b7-4cb9-9528-07cb57dc8ff3">
      <UserInfo>
        <DisplayName>Raise Ahmad</DisplayName>
        <AccountId>73</AccountId>
        <AccountType/>
      </UserInfo>
      <UserInfo>
        <DisplayName>Julie Dalziel</DisplayName>
        <AccountId>26</AccountId>
        <AccountType/>
      </UserInfo>
    </SharedWithUsers>
  </documentManagement>
</p:properties>
</file>

<file path=customXml/item4.xml><?xml version="1.0" encoding="utf-8"?>
<?mso-contentType ?>
<SharedContentType xmlns="Microsoft.SharePoint.Taxonomy.ContentTypeSync" SourceId="12bbd033-7c10-4bc6-94c7-41b14f0b8859" ContentTypeId="0x0101" PreviousValue="false"/>
</file>

<file path=customXml/itemProps1.xml><?xml version="1.0" encoding="utf-8"?>
<ds:datastoreItem xmlns:ds="http://schemas.openxmlformats.org/officeDocument/2006/customXml" ds:itemID="{51F1CDA2-74A0-45AC-8B7A-E06CD939CF91}">
  <ds:schemaRefs>
    <ds:schemaRef ds:uri="7eac3473-afb6-4782-ba55-074fa82562bd"/>
    <ds:schemaRef ds:uri="8274269c-7923-44e4-a9bb-32208af8880d"/>
    <ds:schemaRef ds:uri="bfb4a7de-d4b7-4cb9-9528-07cb57dc8ff3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openxmlformats.org/package/2006/metadata/core-properties"/>
    <ds:schemaRef ds:uri="http://www.w3.org/2001/XMLSchema"/>
  </ds:schemaRefs>
</ds:datastoreItem>
</file>

<file path=customXml/itemProps2.xml><?xml version="1.0" encoding="utf-8"?>
<ds:datastoreItem xmlns:ds="http://schemas.openxmlformats.org/officeDocument/2006/customXml" ds:itemID="{39C2EB77-7FCA-4F94-AAFD-7A9004850B49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4442D5D3-2868-4F87-BD89-EDF3D537E535}">
  <ds:schemaRefs>
    <ds:schemaRef ds:uri="http://schemas.microsoft.com/office/infopath/2007/PartnerControls"/>
    <ds:schemaRef ds:uri="http://purl.org/dc/elements/1.1/"/>
    <ds:schemaRef ds:uri="http://schemas.microsoft.com/office/2006/metadata/properties"/>
    <ds:schemaRef ds:uri="http://schemas.microsoft.com/office/2006/documentManagement/types"/>
    <ds:schemaRef ds:uri="8274269c-7923-44e4-a9bb-32208af8880d"/>
    <ds:schemaRef ds:uri="http://purl.org/dc/terms/"/>
    <ds:schemaRef ds:uri="http://schemas.openxmlformats.org/package/2006/metadata/core-properties"/>
    <ds:schemaRef ds:uri="http://purl.org/dc/dcmitype/"/>
    <ds:schemaRef ds:uri="bfb4a7de-d4b7-4cb9-9528-07cb57dc8ff3"/>
    <ds:schemaRef ds:uri="7eac3473-afb6-4782-ba55-074fa82562bd"/>
    <ds:schemaRef ds:uri="http://www.w3.org/XML/1998/namespace"/>
  </ds:schemaRefs>
</ds:datastoreItem>
</file>

<file path=customXml/itemProps4.xml><?xml version="1.0" encoding="utf-8"?>
<ds:datastoreItem xmlns:ds="http://schemas.openxmlformats.org/officeDocument/2006/customXml" ds:itemID="{46FBBB1F-92A4-46F9-AA48-541D85ABFBA7}">
  <ds:schemaRefs>
    <ds:schemaRef ds:uri="Microsoft.SharePoint.Taxonomy.ContentTypeSync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247</TotalTime>
  <Words>296</Words>
  <Application>Microsoft Office PowerPoint</Application>
  <PresentationFormat>A4 Paper (210x297 mm)</PresentationFormat>
  <Paragraphs>10</Paragraphs>
  <Slides>5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AgResearc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osia Zobel</dc:creator>
  <cp:lastModifiedBy>Julie Dalziel</cp:lastModifiedBy>
  <cp:revision>3</cp:revision>
  <cp:lastPrinted>2025-06-24T04:43:11Z</cp:lastPrinted>
  <dcterms:created xsi:type="dcterms:W3CDTF">2023-06-30T00:59:31Z</dcterms:created>
  <dcterms:modified xsi:type="dcterms:W3CDTF">2026-03-10T01:46:2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C13AD53298B754B937F0D42A18DF9C3</vt:lpwstr>
  </property>
  <property fmtid="{D5CDD505-2E9C-101B-9397-08002B2CF9AE}" pid="3" name="MediaServiceImageTags">
    <vt:lpwstr/>
  </property>
</Properties>
</file>